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60" r:id="rId2"/>
    <p:sldId id="266" r:id="rId3"/>
    <p:sldId id="261" r:id="rId4"/>
    <p:sldId id="267" r:id="rId5"/>
    <p:sldId id="262" r:id="rId6"/>
    <p:sldId id="268" r:id="rId7"/>
    <p:sldId id="264" r:id="rId8"/>
    <p:sldId id="269" r:id="rId9"/>
    <p:sldId id="270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0090" autoAdjust="0"/>
  </p:normalViewPr>
  <p:slideViewPr>
    <p:cSldViewPr snapToGrid="0">
      <p:cViewPr varScale="1">
        <p:scale>
          <a:sx n="84" d="100"/>
          <a:sy n="84" d="100"/>
        </p:scale>
        <p:origin x="102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2A1CC3-C4D6-4E48-8BDD-9BD648061C5F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9B6850-A4B0-4AA4-AEC0-5A70E88D2B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2236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follow-up time for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, overall survival ; PFS, progression-free survival. </a:t>
            </a:r>
            <a:endParaRPr lang="zh-CN" alt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7287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between DDR gene mutation statu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3622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curves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wild-type EGFR and ALK patients. </a:t>
            </a:r>
          </a:p>
          <a:p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DRwt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DDR wild-type; </a:t>
            </a:r>
            <a:r>
              <a:rPr lang="en-US" altLang="zh-CN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DRmut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mutation.</a:t>
            </a:r>
          </a:p>
          <a:p>
            <a:endParaRPr lang="en-US" altLang="zh-CN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21446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between DDR gene mutation statu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933854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between DDR gene mutation statu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8678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between DDR gene mutation statu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95628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association between DDR gene mutation status and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f progression-free survival (PFS) (A) and overall survival (OS) (B)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9B6850-A4B0-4AA4-AEC0-5A70E88D2B6C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92470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C1197-74D4-4853-953F-1F4B81243731}" type="datetimeFigureOut">
              <a:rPr lang="zh-CN" altLang="en-US" smtClean="0"/>
              <a:t>2021/5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A8235A-7CBC-47D8-9604-A4BED5B150C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9370" y="0"/>
            <a:ext cx="10956925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erfall plot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coplo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f the distribution of mutation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88"/>
          <a:stretch/>
        </p:blipFill>
        <p:spPr>
          <a:xfrm>
            <a:off x="1954305" y="1079793"/>
            <a:ext cx="8778868" cy="555346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-1" y="0"/>
            <a:ext cx="119499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Kaplan-Meie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ves of OS in the wild-type EGFR an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K patient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or without KEAP1/NFE2L2 mutations receive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ezolizuma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cetaxe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AK/POPLAR cohort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022632" y="1147481"/>
            <a:ext cx="9851740" cy="5414684"/>
            <a:chOff x="1066800" y="1192304"/>
            <a:chExt cx="9851740" cy="5414684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4" t="4575" r="6037" b="65490"/>
            <a:stretch/>
          </p:blipFill>
          <p:spPr>
            <a:xfrm>
              <a:off x="1066800" y="1192304"/>
              <a:ext cx="6346152" cy="2599767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61" t="36340" r="51905" b="34380"/>
            <a:stretch/>
          </p:blipFill>
          <p:spPr>
            <a:xfrm>
              <a:off x="7691718" y="1210234"/>
              <a:ext cx="3056966" cy="2555075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9" t="68890" r="6196" b="1306"/>
            <a:stretch/>
          </p:blipFill>
          <p:spPr>
            <a:xfrm>
              <a:off x="4383741" y="3917576"/>
              <a:ext cx="6534799" cy="2689412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793" t="36209" r="6514" b="34379"/>
            <a:stretch/>
          </p:blipFill>
          <p:spPr>
            <a:xfrm>
              <a:off x="1066801" y="3917576"/>
              <a:ext cx="3215342" cy="268941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463579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14339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icacy of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ezolizumab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cetaxel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B) between KEAP1/NFE2L2 wild-type and KEAP1/NFE2L2 mutation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0957" y="1382283"/>
            <a:ext cx="9717075" cy="4203507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0874372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Kaplan-Meie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curve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 i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ezolizuma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wild-type EGFR and ALK patients with or without KEAP1/NFE2L2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020" y="1682130"/>
            <a:ext cx="11864340" cy="28414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6611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-1" y="0"/>
            <a:ext cx="117258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vival curve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 i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ezolizuma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patients with or without KEAP1/NFE2L2 mutation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PD-L1 expressi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.</a:t>
            </a:r>
          </a:p>
          <a:p>
            <a:pPr>
              <a:lnSpc>
                <a:spcPct val="150000"/>
              </a:lnSpc>
            </a:pP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3475" y="1407092"/>
            <a:ext cx="11502359" cy="3942148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0874372" cy="3361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curve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cetaxel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wild-type EGFR and ALK patients with or without KEAP1/NFE2L2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tion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787" y="1528367"/>
            <a:ext cx="11888153" cy="29426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106100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0"/>
            <a:ext cx="108743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survival curve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</a:t>
            </a:r>
            <a:r>
              <a:rPr lang="en-US" altLang="zh-CN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cetaxel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ed patients with or without KEAP1/NFE2L2 mutations based on PD-L1 expression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6814" y="1453171"/>
            <a:ext cx="11324666" cy="3549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55896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-1" y="0"/>
            <a:ext cx="1143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8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iolin plot comparing TMB levels between SRP-mutant an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P-wide-type in OAK/POPLAR and in-house Chinese NSCLC cohort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837" y="1478220"/>
            <a:ext cx="11904420" cy="3589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36006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/>
          <p:cNvSpPr txBox="1"/>
          <p:nvPr/>
        </p:nvSpPr>
        <p:spPr>
          <a:xfrm>
            <a:off x="0" y="79863"/>
            <a:ext cx="1143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9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plo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ng PD-L1 expressions between SRP-mutant an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RP-wide-typ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OAK and in-house Chinese NSCLC cohort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802829" y="1755138"/>
            <a:ext cx="376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7051617" y="1755138"/>
            <a:ext cx="376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5517" y="2305898"/>
            <a:ext cx="4544483" cy="3895271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2648" y="2411067"/>
            <a:ext cx="4421786" cy="37901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48753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</TotalTime>
  <Words>412</Words>
  <Application>Microsoft Office PowerPoint</Application>
  <PresentationFormat>宽屏</PresentationFormat>
  <Paragraphs>29</Paragraphs>
  <Slides>9</Slides>
  <Notes>7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5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404795585@qq.com</dc:creator>
  <cp:lastModifiedBy>liuxy</cp:lastModifiedBy>
  <cp:revision>99</cp:revision>
  <dcterms:created xsi:type="dcterms:W3CDTF">2020-08-03T13:54:00Z</dcterms:created>
  <dcterms:modified xsi:type="dcterms:W3CDTF">2021-05-26T15:58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828</vt:lpwstr>
  </property>
</Properties>
</file>